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5" r:id="rId2"/>
    <p:sldId id="268" r:id="rId3"/>
    <p:sldId id="270" r:id="rId4"/>
    <p:sldId id="271" r:id="rId5"/>
    <p:sldId id="272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735"/>
    <p:restoredTop sz="94714"/>
  </p:normalViewPr>
  <p:slideViewPr>
    <p:cSldViewPr snapToGrid="0" snapToObjects="1">
      <p:cViewPr varScale="1">
        <p:scale>
          <a:sx n="77" d="100"/>
          <a:sy n="77" d="100"/>
        </p:scale>
        <p:origin x="175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2C552-9A39-3940-9B3B-FDA66A162B74}" type="datetimeFigureOut">
              <a:rPr lang="en-US" smtClean="0"/>
              <a:t>8/3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65EC4-193B-3546-85E7-2091062CF3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6995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2C552-9A39-3940-9B3B-FDA66A162B74}" type="datetimeFigureOut">
              <a:rPr lang="en-US" smtClean="0"/>
              <a:t>8/3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65EC4-193B-3546-85E7-2091062CF3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58053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2C552-9A39-3940-9B3B-FDA66A162B74}" type="datetimeFigureOut">
              <a:rPr lang="en-US" smtClean="0"/>
              <a:t>8/3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65EC4-193B-3546-85E7-2091062CF3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91574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2C552-9A39-3940-9B3B-FDA66A162B74}" type="datetimeFigureOut">
              <a:rPr lang="en-US" smtClean="0"/>
              <a:t>8/3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65EC4-193B-3546-85E7-2091062CF3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3503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2C552-9A39-3940-9B3B-FDA66A162B74}" type="datetimeFigureOut">
              <a:rPr lang="en-US" smtClean="0"/>
              <a:t>8/3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65EC4-193B-3546-85E7-2091062CF3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72254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2C552-9A39-3940-9B3B-FDA66A162B74}" type="datetimeFigureOut">
              <a:rPr lang="en-US" smtClean="0"/>
              <a:t>8/3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65EC4-193B-3546-85E7-2091062CF3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9849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2C552-9A39-3940-9B3B-FDA66A162B74}" type="datetimeFigureOut">
              <a:rPr lang="en-US" smtClean="0"/>
              <a:t>8/30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65EC4-193B-3546-85E7-2091062CF3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0089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2C552-9A39-3940-9B3B-FDA66A162B74}" type="datetimeFigureOut">
              <a:rPr lang="en-US" smtClean="0"/>
              <a:t>8/30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65EC4-193B-3546-85E7-2091062CF3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46857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2C552-9A39-3940-9B3B-FDA66A162B74}" type="datetimeFigureOut">
              <a:rPr lang="en-US" smtClean="0"/>
              <a:t>8/30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65EC4-193B-3546-85E7-2091062CF3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6815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2C552-9A39-3940-9B3B-FDA66A162B74}" type="datetimeFigureOut">
              <a:rPr lang="en-US" smtClean="0"/>
              <a:t>8/3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65EC4-193B-3546-85E7-2091062CF3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92834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2C552-9A39-3940-9B3B-FDA66A162B74}" type="datetimeFigureOut">
              <a:rPr lang="en-US" smtClean="0"/>
              <a:t>8/3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65EC4-193B-3546-85E7-2091062CF3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39644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12C552-9A39-3940-9B3B-FDA66A162B74}" type="datetimeFigureOut">
              <a:rPr lang="en-US" smtClean="0"/>
              <a:t>8/3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365EC4-193B-3546-85E7-2091062CF3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28707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7" Type="http://schemas.openxmlformats.org/officeDocument/2006/relationships/image" Target="../media/image10.png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tiff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E804555D-F1AB-9633-06FA-D048EEF8999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20962"/>
            <a:ext cx="6858000" cy="3178666"/>
          </a:xfrm>
          <a:prstGeom prst="rect">
            <a:avLst/>
          </a:prstGeom>
        </p:spPr>
      </p:pic>
      <p:sp>
        <p:nvSpPr>
          <p:cNvPr id="17" name="Rectangle 16">
            <a:extLst>
              <a:ext uri="{FF2B5EF4-FFF2-40B4-BE49-F238E27FC236}">
                <a16:creationId xmlns:a16="http://schemas.microsoft.com/office/drawing/2014/main" id="{53B6E36E-8B7C-4E5F-4838-750ADF79E8E0}"/>
              </a:ext>
            </a:extLst>
          </p:cNvPr>
          <p:cNvSpPr/>
          <p:nvPr/>
        </p:nvSpPr>
        <p:spPr>
          <a:xfrm>
            <a:off x="43623" y="3844732"/>
            <a:ext cx="6814377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AU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1 </a:t>
            </a:r>
            <a:r>
              <a:rPr lang="en-AU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enn diagram of (a) known and (b) novel miRNAs identified in 12 capsicum libraries. </a:t>
            </a:r>
            <a:r>
              <a:rPr lang="en-AU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ree biological repeat libraries for each of the treatments were grouped into four datasets: capsicum chlorosis virus (</a:t>
            </a:r>
            <a:r>
              <a:rPr lang="en-AU" sz="140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CV</a:t>
            </a:r>
            <a:r>
              <a:rPr lang="en-AU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-infected capsicum grown at ambient temperature (AV), mock-inoculated capsicum grown at ambient temperature (AM), </a:t>
            </a:r>
            <a:r>
              <a:rPr lang="en-AU" sz="140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CV</a:t>
            </a:r>
            <a:r>
              <a:rPr lang="en-AU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infected capsicum grown at higher temperature (HV), and mock-inoculated capsicum grown at higher temperature (HM)</a:t>
            </a:r>
            <a:r>
              <a:rPr lang="en-AU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. </a:t>
            </a:r>
            <a:endParaRPr lang="en-US" sz="14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31901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F3F6764C-5ED2-FA42-3FE5-085E9360A72C}"/>
              </a:ext>
            </a:extLst>
          </p:cNvPr>
          <p:cNvSpPr txBox="1"/>
          <p:nvPr/>
        </p:nvSpPr>
        <p:spPr>
          <a:xfrm>
            <a:off x="523653" y="6103732"/>
            <a:ext cx="5972840" cy="24622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AU" sz="14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Figure S2 </a:t>
            </a:r>
            <a:r>
              <a:rPr lang="en-AU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Venn diagrams of four pairwise comparisons showing (a) up-regulated miRNAs and (c) their corresponding targets, and (b) down-regulated miRNAs and (d) their corresponding targets. The pairwise comparisons for differentially expressed miRNAs and their corresponding target mRNAs are: 1. capsicum chlorosis virus (</a:t>
            </a:r>
            <a:r>
              <a:rPr lang="en-AU" sz="140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CaCV</a:t>
            </a:r>
            <a:r>
              <a:rPr lang="en-AU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)-infected capsicum grown at ambient temperature (AT) compared to mock-inoculated capsicum grown at AT (AV vs AM); 2. </a:t>
            </a:r>
            <a:r>
              <a:rPr lang="en-AU" sz="140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CaCV</a:t>
            </a:r>
            <a:r>
              <a:rPr lang="en-AU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-infected capsicum grown at high temperature (HT) compared to mock-inoculated capsicum grown at HT (HV vs HM); 3. mock-inoculated capsicum grown at HT compared to AT (HM vs AM); 4. </a:t>
            </a:r>
            <a:r>
              <a:rPr lang="en-AU" sz="140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CaCV</a:t>
            </a:r>
            <a:r>
              <a:rPr lang="en-AU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-infected capsicum grown at HT compared to AT (HV vs AV).</a:t>
            </a:r>
            <a:r>
              <a:rPr lang="en-AU" sz="1400" dirty="0">
                <a:effectLst/>
                <a:latin typeface="Palatino Linotype" panose="02040502050505030304" pitchFamily="18" charset="0"/>
              </a:rPr>
              <a:t> </a:t>
            </a:r>
            <a:endParaRPr lang="en-US" sz="1400" dirty="0">
              <a:latin typeface="Palatino Linotype" panose="0204050205050503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3F4B055-1770-A0F2-60E1-A30DCD1D63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6234"/>
            <a:ext cx="6858000" cy="56429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047566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F902863-BDBC-4F3E-950D-85B5F4836C0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07382"/>
            <a:ext cx="6858000" cy="716367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D6D08DA-B747-3968-0F15-1D45D51099C2}"/>
              </a:ext>
            </a:extLst>
          </p:cNvPr>
          <p:cNvSpPr txBox="1"/>
          <p:nvPr/>
        </p:nvSpPr>
        <p:spPr>
          <a:xfrm>
            <a:off x="332268" y="7371053"/>
            <a:ext cx="6355612" cy="18158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AU" sz="14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Figure S3 </a:t>
            </a:r>
            <a:r>
              <a:rPr lang="en-AU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 (Body CS)"/>
              </a:rPr>
              <a:t>Acyclic graph showing hierarchical relationship of the enriched gene ontology (GO) terms in the biological process category. </a:t>
            </a:r>
            <a:r>
              <a:rPr lang="en-AU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GO terms are associated with (a) targets predicted from down-regulated miRNAs in </a:t>
            </a:r>
            <a:r>
              <a:rPr lang="en-AU" sz="140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CaCV</a:t>
            </a:r>
            <a:r>
              <a:rPr lang="en-AU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-infected capsicum grown at AT compared to mock-inoculated capsicum grown at AT; (b) targets predicted from up-regulated miRNAs in </a:t>
            </a:r>
            <a:r>
              <a:rPr lang="en-AU" sz="140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CaCV</a:t>
            </a:r>
            <a:r>
              <a:rPr lang="en-AU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-infected capsicum grown at HT compared to mock-inoculated capsicum grown at HT. The </a:t>
            </a:r>
            <a:r>
              <a:rPr lang="en-AU" sz="140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color</a:t>
            </a:r>
            <a:r>
              <a:rPr lang="en-AU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scale from yellow to red indicates an increasingly significant enrichment of GO terms.</a:t>
            </a:r>
            <a:r>
              <a:rPr lang="en-AU" sz="1400" dirty="0">
                <a:effectLst/>
                <a:latin typeface="Palatino Linotype" panose="02040502050505030304" pitchFamily="18" charset="0"/>
              </a:rPr>
              <a:t> </a:t>
            </a:r>
            <a:endParaRPr lang="en-US" sz="14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34806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47495D8-E8AD-0CF0-80D8-D43085B9DA1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923837"/>
            <a:ext cx="6858000" cy="402916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0366738-6586-BF7F-D85A-EEE8B22767F3}"/>
              </a:ext>
            </a:extLst>
          </p:cNvPr>
          <p:cNvSpPr txBox="1"/>
          <p:nvPr/>
        </p:nvSpPr>
        <p:spPr>
          <a:xfrm>
            <a:off x="251194" y="5425295"/>
            <a:ext cx="6355612" cy="18158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AU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Figure S4</a:t>
            </a:r>
            <a:r>
              <a:rPr lang="en-AU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 </a:t>
            </a:r>
            <a:r>
              <a:rPr lang="en-AU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 (Body CS)"/>
              </a:rPr>
              <a:t>Acyclic graph showing hierarchical relationship of the enriched gene ontology (GO) terms in the molecular function category. </a:t>
            </a:r>
            <a:r>
              <a:rPr lang="en-AU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GO terms are associated with (a) targets predicted from down-regulated miRNAs in </a:t>
            </a:r>
            <a:r>
              <a:rPr lang="en-AU" sz="140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CaCV</a:t>
            </a:r>
            <a:r>
              <a:rPr lang="en-AU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-infected capsicum grown at AT compared to mock-inoculated capsicum grown at AT; (b) targets predicted from up-regulated miRNAs in </a:t>
            </a:r>
            <a:r>
              <a:rPr lang="en-AU" sz="140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CaCV</a:t>
            </a:r>
            <a:r>
              <a:rPr lang="en-AU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-infected capsicum grown at HT compared to mock-inoculated capsicum grown at HT. The </a:t>
            </a:r>
            <a:r>
              <a:rPr lang="en-AU" sz="140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color</a:t>
            </a:r>
            <a:r>
              <a:rPr lang="en-AU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scale from yellow to red indicates an increasingly significant enrichment of GO terms.</a:t>
            </a:r>
            <a:r>
              <a:rPr lang="en-AU" sz="1400" dirty="0">
                <a:effectLst/>
                <a:latin typeface="Palatino Linotype" panose="02040502050505030304" pitchFamily="18" charset="0"/>
              </a:rPr>
              <a:t>  </a:t>
            </a:r>
            <a:endParaRPr lang="en-US" sz="14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37266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B75D9691-12E8-1ADF-B8AE-CCADB28B880B}"/>
              </a:ext>
            </a:extLst>
          </p:cNvPr>
          <p:cNvGrpSpPr/>
          <p:nvPr/>
        </p:nvGrpSpPr>
        <p:grpSpPr>
          <a:xfrm>
            <a:off x="76965" y="2592025"/>
            <a:ext cx="6155517" cy="1119450"/>
            <a:chOff x="3010798" y="5449697"/>
            <a:chExt cx="6566852" cy="1174520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803BB98A-1953-A2E3-A98F-FE758668636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20637" t="13145" b="17526"/>
            <a:stretch/>
          </p:blipFill>
          <p:spPr>
            <a:xfrm>
              <a:off x="3857394" y="5986780"/>
              <a:ext cx="1846705" cy="637437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650702BA-01D9-8D5A-85D3-1AB87594C56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13588" b="12870"/>
            <a:stretch/>
          </p:blipFill>
          <p:spPr>
            <a:xfrm>
              <a:off x="3857396" y="5449697"/>
              <a:ext cx="1757728" cy="427452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E491A44-2517-0AA4-F649-BF690DABC735}"/>
                </a:ext>
              </a:extLst>
            </p:cNvPr>
            <p:cNvSpPr txBox="1"/>
            <p:nvPr/>
          </p:nvSpPr>
          <p:spPr>
            <a:xfrm>
              <a:off x="3323362" y="6179740"/>
              <a:ext cx="812800" cy="3229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6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9642998-65EA-F5FD-65CE-87B597C9DFA2}"/>
                </a:ext>
              </a:extLst>
            </p:cNvPr>
            <p:cNvSpPr txBox="1"/>
            <p:nvPr/>
          </p:nvSpPr>
          <p:spPr>
            <a:xfrm>
              <a:off x="3010798" y="5542303"/>
              <a:ext cx="1016575" cy="3229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R164</a:t>
              </a:r>
            </a:p>
          </p:txBody>
        </p:sp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227C23E3-A629-E2C5-9BC7-5DC117977A7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10206" b="13155"/>
            <a:stretch/>
          </p:blipFill>
          <p:spPr>
            <a:xfrm>
              <a:off x="7819923" y="5449697"/>
              <a:ext cx="1757727" cy="411612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B3540792-0853-0C89-4DDA-D495A6D24DE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954327" y="6127822"/>
              <a:ext cx="1623323" cy="411611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8CFE8274-09D9-9050-9844-1B0B02B1725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831732" y="5454775"/>
              <a:ext cx="1757727" cy="424195"/>
            </a:xfrm>
            <a:prstGeom prst="rect">
              <a:avLst/>
            </a:prstGeom>
          </p:spPr>
        </p:pic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B7ADE457-B7FF-CAC6-A138-F1F721ECCF3F}"/>
              </a:ext>
            </a:extLst>
          </p:cNvPr>
          <p:cNvGrpSpPr/>
          <p:nvPr/>
        </p:nvGrpSpPr>
        <p:grpSpPr>
          <a:xfrm>
            <a:off x="872839" y="2255792"/>
            <a:ext cx="1766824" cy="307942"/>
            <a:chOff x="834739" y="2179592"/>
            <a:chExt cx="1766824" cy="307942"/>
          </a:xfrm>
        </p:grpSpPr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45A3415D-3DA3-70CF-0A24-18D6F019F6A6}"/>
                </a:ext>
              </a:extLst>
            </p:cNvPr>
            <p:cNvSpPr txBox="1"/>
            <p:nvPr/>
          </p:nvSpPr>
          <p:spPr>
            <a:xfrm>
              <a:off x="834739" y="2179592"/>
              <a:ext cx="568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M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5017D87F-F6F6-5B2D-1955-9D1713A278C1}"/>
                </a:ext>
              </a:extLst>
            </p:cNvPr>
            <p:cNvSpPr txBox="1"/>
            <p:nvPr/>
          </p:nvSpPr>
          <p:spPr>
            <a:xfrm>
              <a:off x="1243063" y="2179757"/>
              <a:ext cx="568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V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61FC9E0D-48D5-B286-E871-E587B363D8F4}"/>
                </a:ext>
              </a:extLst>
            </p:cNvPr>
            <p:cNvSpPr txBox="1"/>
            <p:nvPr/>
          </p:nvSpPr>
          <p:spPr>
            <a:xfrm>
              <a:off x="1599051" y="2179592"/>
              <a:ext cx="568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M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8F124A66-461A-19B2-C06F-75D787E1FB7A}"/>
                </a:ext>
              </a:extLst>
            </p:cNvPr>
            <p:cNvSpPr txBox="1"/>
            <p:nvPr/>
          </p:nvSpPr>
          <p:spPr>
            <a:xfrm>
              <a:off x="2032763" y="2179757"/>
              <a:ext cx="568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V</a:t>
              </a:r>
            </a:p>
          </p:txBody>
        </p:sp>
      </p:grpSp>
      <p:pic>
        <p:nvPicPr>
          <p:cNvPr id="20" name="Picture 19">
            <a:extLst>
              <a:ext uri="{FF2B5EF4-FFF2-40B4-BE49-F238E27FC236}">
                <a16:creationId xmlns:a16="http://schemas.microsoft.com/office/drawing/2014/main" id="{9EB153A5-AF3E-490B-C766-FC300930B90A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6029" b="20195"/>
          <a:stretch/>
        </p:blipFill>
        <p:spPr>
          <a:xfrm>
            <a:off x="2721201" y="3213100"/>
            <a:ext cx="1610643" cy="442827"/>
          </a:xfrm>
          <a:prstGeom prst="rect">
            <a:avLst/>
          </a:prstGeom>
        </p:spPr>
      </p:pic>
      <p:grpSp>
        <p:nvGrpSpPr>
          <p:cNvPr id="23" name="Group 22">
            <a:extLst>
              <a:ext uri="{FF2B5EF4-FFF2-40B4-BE49-F238E27FC236}">
                <a16:creationId xmlns:a16="http://schemas.microsoft.com/office/drawing/2014/main" id="{50AA4D1D-8339-24FA-A83E-60D8EADBE817}"/>
              </a:ext>
            </a:extLst>
          </p:cNvPr>
          <p:cNvGrpSpPr/>
          <p:nvPr/>
        </p:nvGrpSpPr>
        <p:grpSpPr>
          <a:xfrm>
            <a:off x="2699491" y="2255792"/>
            <a:ext cx="1766824" cy="307942"/>
            <a:chOff x="834739" y="2179592"/>
            <a:chExt cx="1766824" cy="307942"/>
          </a:xfrm>
        </p:grpSpPr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936E80F6-817D-D704-F604-E5D76CDB62F4}"/>
                </a:ext>
              </a:extLst>
            </p:cNvPr>
            <p:cNvSpPr txBox="1"/>
            <p:nvPr/>
          </p:nvSpPr>
          <p:spPr>
            <a:xfrm>
              <a:off x="834739" y="2179592"/>
              <a:ext cx="568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M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27F081C7-21CD-4213-4F74-3678EF96490B}"/>
                </a:ext>
              </a:extLst>
            </p:cNvPr>
            <p:cNvSpPr txBox="1"/>
            <p:nvPr/>
          </p:nvSpPr>
          <p:spPr>
            <a:xfrm>
              <a:off x="1243063" y="2179757"/>
              <a:ext cx="568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V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929050D4-F118-96DE-B4DE-1FDBB2C4C6FC}"/>
                </a:ext>
              </a:extLst>
            </p:cNvPr>
            <p:cNvSpPr txBox="1"/>
            <p:nvPr/>
          </p:nvSpPr>
          <p:spPr>
            <a:xfrm>
              <a:off x="1599051" y="2179592"/>
              <a:ext cx="568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M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0B9903A5-0965-15B1-01E8-011FEF685744}"/>
                </a:ext>
              </a:extLst>
            </p:cNvPr>
            <p:cNvSpPr txBox="1"/>
            <p:nvPr/>
          </p:nvSpPr>
          <p:spPr>
            <a:xfrm>
              <a:off x="2032763" y="2179757"/>
              <a:ext cx="568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V</a:t>
              </a:r>
            </a:p>
          </p:txBody>
        </p:sp>
      </p:grpSp>
      <p:grpSp>
        <p:nvGrpSpPr>
          <p:cNvPr id="28" name="Group 27">
            <a:extLst>
              <a:ext uri="{FF2B5EF4-FFF2-40B4-BE49-F238E27FC236}">
                <a16:creationId xmlns:a16="http://schemas.microsoft.com/office/drawing/2014/main" id="{C710FCF8-DC5A-3CE5-4A15-E9BC794260BF}"/>
              </a:ext>
            </a:extLst>
          </p:cNvPr>
          <p:cNvGrpSpPr/>
          <p:nvPr/>
        </p:nvGrpSpPr>
        <p:grpSpPr>
          <a:xfrm>
            <a:off x="4525257" y="2268488"/>
            <a:ext cx="1766824" cy="307942"/>
            <a:chOff x="834739" y="2179592"/>
            <a:chExt cx="1766824" cy="307942"/>
          </a:xfrm>
        </p:grpSpPr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952EBF37-EA68-379D-7370-836A2478949A}"/>
                </a:ext>
              </a:extLst>
            </p:cNvPr>
            <p:cNvSpPr txBox="1"/>
            <p:nvPr/>
          </p:nvSpPr>
          <p:spPr>
            <a:xfrm>
              <a:off x="834739" y="2179592"/>
              <a:ext cx="568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M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7BE510A6-EFF2-B1F4-9A47-4DB0FB1B516A}"/>
                </a:ext>
              </a:extLst>
            </p:cNvPr>
            <p:cNvSpPr txBox="1"/>
            <p:nvPr/>
          </p:nvSpPr>
          <p:spPr>
            <a:xfrm>
              <a:off x="1243063" y="2179757"/>
              <a:ext cx="568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V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9479A466-FA90-B424-108E-83FE25B8DCA9}"/>
                </a:ext>
              </a:extLst>
            </p:cNvPr>
            <p:cNvSpPr txBox="1"/>
            <p:nvPr/>
          </p:nvSpPr>
          <p:spPr>
            <a:xfrm>
              <a:off x="1599051" y="2179592"/>
              <a:ext cx="568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M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9E191E02-B8E3-A48D-1806-AD2A9D69A792}"/>
                </a:ext>
              </a:extLst>
            </p:cNvPr>
            <p:cNvSpPr txBox="1"/>
            <p:nvPr/>
          </p:nvSpPr>
          <p:spPr>
            <a:xfrm>
              <a:off x="2032763" y="2179757"/>
              <a:ext cx="568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V</a:t>
              </a:r>
            </a:p>
          </p:txBody>
        </p:sp>
      </p:grpSp>
      <p:sp>
        <p:nvSpPr>
          <p:cNvPr id="33" name="TextBox 32">
            <a:extLst>
              <a:ext uri="{FF2B5EF4-FFF2-40B4-BE49-F238E27FC236}">
                <a16:creationId xmlns:a16="http://schemas.microsoft.com/office/drawing/2014/main" id="{2C6423E4-26F0-72E7-0665-5F5BCBAC50D7}"/>
              </a:ext>
            </a:extLst>
          </p:cNvPr>
          <p:cNvSpPr txBox="1"/>
          <p:nvPr/>
        </p:nvSpPr>
        <p:spPr>
          <a:xfrm>
            <a:off x="214409" y="3965492"/>
            <a:ext cx="6237191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AU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5 </a:t>
            </a:r>
            <a:r>
              <a:rPr lang="en-AU" sz="14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AU" sz="1400" dirty="0">
                <a:effectLst/>
                <a:latin typeface="Palatino Linotype" panose="02040502050505030304" pitchFamily="18" charset="0"/>
                <a:cs typeface="Times New Roman" panose="02020603050405020304" pitchFamily="18" charset="0"/>
              </a:rPr>
              <a:t>orthern hybridizations showing </a:t>
            </a:r>
            <a:r>
              <a:rPr lang="en-AU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t</a:t>
            </a:r>
            <a:r>
              <a:rPr lang="en-AU" sz="1400" dirty="0">
                <a:effectLst/>
                <a:latin typeface="Palatino Linotype" panose="02040502050505030304" pitchFamily="18" charset="0"/>
                <a:cs typeface="Times New Roman" panose="02020603050405020304" pitchFamily="18" charset="0"/>
              </a:rPr>
              <a:t>he abundance of miR164 in mock or </a:t>
            </a:r>
            <a:r>
              <a:rPr lang="en-AU" sz="1400" dirty="0" err="1">
                <a:effectLst/>
                <a:latin typeface="Palatino Linotype" panose="02040502050505030304" pitchFamily="18" charset="0"/>
                <a:cs typeface="Times New Roman" panose="02020603050405020304" pitchFamily="18" charset="0"/>
              </a:rPr>
              <a:t>CaCV</a:t>
            </a:r>
            <a:r>
              <a:rPr lang="en-AU" sz="1400" dirty="0">
                <a:effectLst/>
                <a:latin typeface="Palatino Linotype" panose="02040502050505030304" pitchFamily="18" charset="0"/>
                <a:cs typeface="Times New Roman" panose="02020603050405020304" pitchFamily="18" charset="0"/>
              </a:rPr>
              <a:t>-infected capsicum plants grown at ambient temperature (AM and AV) or high temperature (HM and HV). U6 was used as an internal control.</a:t>
            </a:r>
          </a:p>
          <a:p>
            <a:pPr algn="just"/>
            <a:r>
              <a:rPr lang="en-AU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en-US" sz="14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5213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839</TotalTime>
  <Words>440</Words>
  <Application>Microsoft Macintosh PowerPoint</Application>
  <PresentationFormat>A4 Paper (210x297 mm)</PresentationFormat>
  <Paragraphs>20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Palatino Linotype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i-An Tsai</dc:creator>
  <cp:lastModifiedBy>Wei-An Tsai</cp:lastModifiedBy>
  <cp:revision>132</cp:revision>
  <dcterms:created xsi:type="dcterms:W3CDTF">2021-02-08T05:27:09Z</dcterms:created>
  <dcterms:modified xsi:type="dcterms:W3CDTF">2024-08-30T09:12:12Z</dcterms:modified>
</cp:coreProperties>
</file>